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5068" autoAdjust="0"/>
    <p:restoredTop sz="94537" autoAdjust="0"/>
  </p:normalViewPr>
  <p:slideViewPr>
    <p:cSldViewPr snapToGrid="0">
      <p:cViewPr>
        <p:scale>
          <a:sx n="80" d="100"/>
          <a:sy n="80" d="100"/>
        </p:scale>
        <p:origin x="1796" y="7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9053BB3-04D9-4B42-A395-5BB3777DD9F4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E26A1C-2188-4D82-8137-630BAC3549F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61206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 smtClean="0"/>
              <a:t>Figure S2: study flow diagram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E26A1C-2188-4D82-8137-630BAC3549FE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62003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2653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40763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797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8379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3658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6057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5163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48632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4329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8832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8359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8C977-A974-4171-BA66-8EBEF38D23EF}" type="datetimeFigureOut">
              <a:rPr lang="en-GB" smtClean="0"/>
              <a:t>09/06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F5A699-5D11-43D9-B948-A851BDC83AB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70211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4080227" y="382114"/>
            <a:ext cx="4085634" cy="4205009"/>
            <a:chOff x="2442258" y="604751"/>
            <a:chExt cx="4085634" cy="4205009"/>
          </a:xfrm>
        </p:grpSpPr>
        <p:sp>
          <p:nvSpPr>
            <p:cNvPr id="4" name="Text Box 1"/>
            <p:cNvSpPr txBox="1">
              <a:spLocks noChangeArrowheads="1"/>
            </p:cNvSpPr>
            <p:nvPr/>
          </p:nvSpPr>
          <p:spPr bwMode="auto">
            <a:xfrm>
              <a:off x="3634305" y="2329099"/>
              <a:ext cx="1625267" cy="276448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,021 women consented 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cxnSp>
          <p:nvCxnSpPr>
            <p:cNvPr id="5" name="Straight Arrow Connector 4"/>
            <p:cNvCxnSpPr/>
            <p:nvPr/>
          </p:nvCxnSpPr>
          <p:spPr>
            <a:xfrm rot="720000">
              <a:off x="3805760" y="2611334"/>
              <a:ext cx="125734" cy="56495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Text Box 3"/>
            <p:cNvSpPr txBox="1">
              <a:spLocks noChangeArrowheads="1"/>
            </p:cNvSpPr>
            <p:nvPr/>
          </p:nvSpPr>
          <p:spPr bwMode="auto">
            <a:xfrm>
              <a:off x="2442258" y="3190804"/>
              <a:ext cx="2043814" cy="389190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,998 women with 6 week medical record check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Text Box 5"/>
            <p:cNvSpPr txBox="1">
              <a:spLocks noChangeArrowheads="1"/>
            </p:cNvSpPr>
            <p:nvPr/>
          </p:nvSpPr>
          <p:spPr bwMode="auto">
            <a:xfrm>
              <a:off x="4500655" y="3190805"/>
              <a:ext cx="2027237" cy="389190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1,213 women with 6 week questionnaire information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Text Box 8"/>
            <p:cNvSpPr txBox="1">
              <a:spLocks noChangeArrowheads="1"/>
            </p:cNvSpPr>
            <p:nvPr/>
          </p:nvSpPr>
          <p:spPr bwMode="auto">
            <a:xfrm>
              <a:off x="3315586" y="4158485"/>
              <a:ext cx="2370138" cy="651275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2,009 women contributing to primary outcome (medical records check OR 6 week questionnaire information)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 rot="720000">
              <a:off x="4999877" y="2613266"/>
              <a:ext cx="125734" cy="56495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/>
            <p:cNvCxnSpPr/>
            <p:nvPr/>
          </p:nvCxnSpPr>
          <p:spPr>
            <a:xfrm rot="720000">
              <a:off x="3813478" y="3587854"/>
              <a:ext cx="125734" cy="56495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 rot="720000">
              <a:off x="5007598" y="3589785"/>
              <a:ext cx="125734" cy="56495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 rot="720000">
              <a:off x="4403439" y="1749940"/>
              <a:ext cx="125734" cy="56495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 Box 1"/>
            <p:cNvSpPr txBox="1">
              <a:spLocks noChangeArrowheads="1"/>
            </p:cNvSpPr>
            <p:nvPr/>
          </p:nvSpPr>
          <p:spPr bwMode="auto">
            <a:xfrm>
              <a:off x="3764943" y="1462289"/>
              <a:ext cx="1400214" cy="276448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,044 women eligibl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cxnSp>
          <p:nvCxnSpPr>
            <p:cNvPr id="22" name="Straight Arrow Connector 21"/>
            <p:cNvCxnSpPr/>
            <p:nvPr/>
          </p:nvCxnSpPr>
          <p:spPr>
            <a:xfrm rot="720000">
              <a:off x="4392063" y="892402"/>
              <a:ext cx="125734" cy="564957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 Box 1"/>
            <p:cNvSpPr txBox="1">
              <a:spLocks noChangeArrowheads="1"/>
            </p:cNvSpPr>
            <p:nvPr/>
          </p:nvSpPr>
          <p:spPr bwMode="auto">
            <a:xfrm>
              <a:off x="3697992" y="604751"/>
              <a:ext cx="1519476" cy="276448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4,826 women screened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3697430" y="4910295"/>
            <a:ext cx="56515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Figure S2: Study flow diagram</a:t>
            </a:r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36406987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53</Words>
  <Application>Microsoft Office PowerPoint</Application>
  <PresentationFormat>Widescreen</PresentationFormat>
  <Paragraphs>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oB IT Servic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ebecca Man (Applied Health Sciences)</dc:creator>
  <cp:lastModifiedBy>Rebecca Man (Applied Health Sciences)</cp:lastModifiedBy>
  <cp:revision>4</cp:revision>
  <dcterms:created xsi:type="dcterms:W3CDTF">2025-02-11T12:25:23Z</dcterms:created>
  <dcterms:modified xsi:type="dcterms:W3CDTF">2025-06-09T15:57:57Z</dcterms:modified>
</cp:coreProperties>
</file>